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62" r:id="rId4"/>
    <p:sldId id="263" r:id="rId5"/>
    <p:sldId id="265" r:id="rId6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D666CCE-47D4-4261-826D-E4EE9BF86D1F}" v="8" dt="2025-06-12T14:01:01.58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43" d="100"/>
          <a:sy n="43" d="100"/>
        </p:scale>
        <p:origin x="2894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my Ward" userId="c9b4cf37-c40f-42c4-812a-4f73567e69c1" providerId="ADAL" clId="{2D666CCE-47D4-4261-826D-E4EE9BF86D1F}"/>
    <pc:docChg chg="undo custSel delSld modSld modMainMaster">
      <pc:chgData name="Amy Ward" userId="c9b4cf37-c40f-42c4-812a-4f73567e69c1" providerId="ADAL" clId="{2D666CCE-47D4-4261-826D-E4EE9BF86D1F}" dt="2025-06-12T14:01:09.439" v="33" actId="47"/>
      <pc:docMkLst>
        <pc:docMk/>
      </pc:docMkLst>
      <pc:sldChg chg="modSp">
        <pc:chgData name="Amy Ward" userId="c9b4cf37-c40f-42c4-812a-4f73567e69c1" providerId="ADAL" clId="{2D666CCE-47D4-4261-826D-E4EE9BF86D1F}" dt="2025-06-12T13:59:01.263" v="0"/>
        <pc:sldMkLst>
          <pc:docMk/>
          <pc:sldMk cId="1887675567" sldId="256"/>
        </pc:sldMkLst>
        <pc:spChg chg="mod">
          <ac:chgData name="Amy Ward" userId="c9b4cf37-c40f-42c4-812a-4f73567e69c1" providerId="ADAL" clId="{2D666CCE-47D4-4261-826D-E4EE9BF86D1F}" dt="2025-06-12T13:59:01.263" v="0"/>
          <ac:spMkLst>
            <pc:docMk/>
            <pc:sldMk cId="1887675567" sldId="256"/>
            <ac:spMk id="2" creationId="{FE73398B-4F10-1231-AFF8-4B59C303BECC}"/>
          </ac:spMkLst>
        </pc:spChg>
        <pc:spChg chg="mod">
          <ac:chgData name="Amy Ward" userId="c9b4cf37-c40f-42c4-812a-4f73567e69c1" providerId="ADAL" clId="{2D666CCE-47D4-4261-826D-E4EE9BF86D1F}" dt="2025-06-12T13:59:01.263" v="0"/>
          <ac:spMkLst>
            <pc:docMk/>
            <pc:sldMk cId="1887675567" sldId="256"/>
            <ac:spMk id="3" creationId="{E76BBFFC-C30D-B307-533F-12DFA136A571}"/>
          </ac:spMkLst>
        </pc:spChg>
      </pc:sldChg>
      <pc:sldChg chg="addSp modSp mod">
        <pc:chgData name="Amy Ward" userId="c9b4cf37-c40f-42c4-812a-4f73567e69c1" providerId="ADAL" clId="{2D666CCE-47D4-4261-826D-E4EE9BF86D1F}" dt="2025-06-12T13:59:47.763" v="8" actId="14100"/>
        <pc:sldMkLst>
          <pc:docMk/>
          <pc:sldMk cId="3915202193" sldId="257"/>
        </pc:sldMkLst>
        <pc:spChg chg="add mod">
          <ac:chgData name="Amy Ward" userId="c9b4cf37-c40f-42c4-812a-4f73567e69c1" providerId="ADAL" clId="{2D666CCE-47D4-4261-826D-E4EE9BF86D1F}" dt="2025-06-12T13:59:47.763" v="8" actId="14100"/>
          <ac:spMkLst>
            <pc:docMk/>
            <pc:sldMk cId="3915202193" sldId="257"/>
            <ac:spMk id="6" creationId="{D989D657-7F77-95B5-DC8F-1145AE3D2E43}"/>
          </ac:spMkLst>
        </pc:spChg>
        <pc:graphicFrameChg chg="mod">
          <ac:chgData name="Amy Ward" userId="c9b4cf37-c40f-42c4-812a-4f73567e69c1" providerId="ADAL" clId="{2D666CCE-47D4-4261-826D-E4EE9BF86D1F}" dt="2025-06-12T13:59:39.487" v="6" actId="1076"/>
          <ac:graphicFrameMkLst>
            <pc:docMk/>
            <pc:sldMk cId="3915202193" sldId="257"/>
            <ac:graphicFrameMk id="5" creationId="{F1C10AFA-1EBE-9515-9D42-A6EEC825A033}"/>
          </ac:graphicFrameMkLst>
        </pc:graphicFrameChg>
      </pc:sldChg>
      <pc:sldChg chg="addSp modSp mod">
        <pc:chgData name="Amy Ward" userId="c9b4cf37-c40f-42c4-812a-4f73567e69c1" providerId="ADAL" clId="{2D666CCE-47D4-4261-826D-E4EE9BF86D1F}" dt="2025-06-12T14:00:16.398" v="16" actId="14100"/>
        <pc:sldMkLst>
          <pc:docMk/>
          <pc:sldMk cId="3552285547" sldId="262"/>
        </pc:sldMkLst>
        <pc:spChg chg="add mod">
          <ac:chgData name="Amy Ward" userId="c9b4cf37-c40f-42c4-812a-4f73567e69c1" providerId="ADAL" clId="{2D666CCE-47D4-4261-826D-E4EE9BF86D1F}" dt="2025-06-12T14:00:16.398" v="16" actId="14100"/>
          <ac:spMkLst>
            <pc:docMk/>
            <pc:sldMk cId="3552285547" sldId="262"/>
            <ac:spMk id="2" creationId="{6404FF49-90E2-5D7B-8D62-37979229465E}"/>
          </ac:spMkLst>
        </pc:spChg>
        <pc:spChg chg="mod">
          <ac:chgData name="Amy Ward" userId="c9b4cf37-c40f-42c4-812a-4f73567e69c1" providerId="ADAL" clId="{2D666CCE-47D4-4261-826D-E4EE9BF86D1F}" dt="2025-06-12T13:59:57.880" v="10" actId="1076"/>
          <ac:spMkLst>
            <pc:docMk/>
            <pc:sldMk cId="3552285547" sldId="262"/>
            <ac:spMk id="7" creationId="{F11283C8-5CFF-C184-09F7-E2E19FB261F9}"/>
          </ac:spMkLst>
        </pc:spChg>
        <pc:spChg chg="mod">
          <ac:chgData name="Amy Ward" userId="c9b4cf37-c40f-42c4-812a-4f73567e69c1" providerId="ADAL" clId="{2D666CCE-47D4-4261-826D-E4EE9BF86D1F}" dt="2025-06-12T13:59:57.880" v="10" actId="1076"/>
          <ac:spMkLst>
            <pc:docMk/>
            <pc:sldMk cId="3552285547" sldId="262"/>
            <ac:spMk id="14" creationId="{80DBB0F5-4D27-5A8E-786B-66650B29A11F}"/>
          </ac:spMkLst>
        </pc:spChg>
        <pc:spChg chg="mod">
          <ac:chgData name="Amy Ward" userId="c9b4cf37-c40f-42c4-812a-4f73567e69c1" providerId="ADAL" clId="{2D666CCE-47D4-4261-826D-E4EE9BF86D1F}" dt="2025-06-12T13:59:57.880" v="10" actId="1076"/>
          <ac:spMkLst>
            <pc:docMk/>
            <pc:sldMk cId="3552285547" sldId="262"/>
            <ac:spMk id="19" creationId="{3F2D6A5F-FCEE-F8EB-B489-940FCED6749D}"/>
          </ac:spMkLst>
        </pc:spChg>
        <pc:spChg chg="mod">
          <ac:chgData name="Amy Ward" userId="c9b4cf37-c40f-42c4-812a-4f73567e69c1" providerId="ADAL" clId="{2D666CCE-47D4-4261-826D-E4EE9BF86D1F}" dt="2025-06-12T13:59:57.880" v="10" actId="1076"/>
          <ac:spMkLst>
            <pc:docMk/>
            <pc:sldMk cId="3552285547" sldId="262"/>
            <ac:spMk id="23" creationId="{F0708FFE-D3C3-2FAF-14E9-D7A02ED8618C}"/>
          </ac:spMkLst>
        </pc:spChg>
        <pc:spChg chg="mod">
          <ac:chgData name="Amy Ward" userId="c9b4cf37-c40f-42c4-812a-4f73567e69c1" providerId="ADAL" clId="{2D666CCE-47D4-4261-826D-E4EE9BF86D1F}" dt="2025-06-12T13:59:01.263" v="0"/>
          <ac:spMkLst>
            <pc:docMk/>
            <pc:sldMk cId="3552285547" sldId="262"/>
            <ac:spMk id="29" creationId="{409EFB58-4316-EA4C-2749-BAC200CC5273}"/>
          </ac:spMkLst>
        </pc:spChg>
        <pc:grpChg chg="mod">
          <ac:chgData name="Amy Ward" userId="c9b4cf37-c40f-42c4-812a-4f73567e69c1" providerId="ADAL" clId="{2D666CCE-47D4-4261-826D-E4EE9BF86D1F}" dt="2025-06-12T13:59:57.880" v="10" actId="1076"/>
          <ac:grpSpMkLst>
            <pc:docMk/>
            <pc:sldMk cId="3552285547" sldId="262"/>
            <ac:grpSpMk id="5" creationId="{973001C7-0682-EAEB-1E0E-40B0EC26AB9D}"/>
          </ac:grpSpMkLst>
        </pc:grpChg>
        <pc:picChg chg="mod">
          <ac:chgData name="Amy Ward" userId="c9b4cf37-c40f-42c4-812a-4f73567e69c1" providerId="ADAL" clId="{2D666CCE-47D4-4261-826D-E4EE9BF86D1F}" dt="2025-06-12T13:59:57.880" v="10" actId="1076"/>
          <ac:picMkLst>
            <pc:docMk/>
            <pc:sldMk cId="3552285547" sldId="262"/>
            <ac:picMk id="3" creationId="{C62A34D4-D32A-A682-940B-D603E817AB5C}"/>
          </ac:picMkLst>
        </pc:picChg>
        <pc:picChg chg="mod">
          <ac:chgData name="Amy Ward" userId="c9b4cf37-c40f-42c4-812a-4f73567e69c1" providerId="ADAL" clId="{2D666CCE-47D4-4261-826D-E4EE9BF86D1F}" dt="2025-06-12T13:59:57.880" v="10" actId="1076"/>
          <ac:picMkLst>
            <pc:docMk/>
            <pc:sldMk cId="3552285547" sldId="262"/>
            <ac:picMk id="4" creationId="{92BB825E-8BD2-4738-56BA-25E09813BEB9}"/>
          </ac:picMkLst>
        </pc:picChg>
        <pc:picChg chg="mod">
          <ac:chgData name="Amy Ward" userId="c9b4cf37-c40f-42c4-812a-4f73567e69c1" providerId="ADAL" clId="{2D666CCE-47D4-4261-826D-E4EE9BF86D1F}" dt="2025-06-12T13:59:57.880" v="10" actId="1076"/>
          <ac:picMkLst>
            <pc:docMk/>
            <pc:sldMk cId="3552285547" sldId="262"/>
            <ac:picMk id="21" creationId="{9FB78F33-52A4-7CAC-D5C0-8285DCCED500}"/>
          </ac:picMkLst>
        </pc:picChg>
        <pc:picChg chg="mod">
          <ac:chgData name="Amy Ward" userId="c9b4cf37-c40f-42c4-812a-4f73567e69c1" providerId="ADAL" clId="{2D666CCE-47D4-4261-826D-E4EE9BF86D1F}" dt="2025-06-12T13:59:57.880" v="10" actId="1076"/>
          <ac:picMkLst>
            <pc:docMk/>
            <pc:sldMk cId="3552285547" sldId="262"/>
            <ac:picMk id="22" creationId="{0C0C48F5-0D40-D943-C167-CE048AEB69B0}"/>
          </ac:picMkLst>
        </pc:picChg>
        <pc:picChg chg="mod">
          <ac:chgData name="Amy Ward" userId="c9b4cf37-c40f-42c4-812a-4f73567e69c1" providerId="ADAL" clId="{2D666CCE-47D4-4261-826D-E4EE9BF86D1F}" dt="2025-06-12T13:59:01.263" v="0"/>
          <ac:picMkLst>
            <pc:docMk/>
            <pc:sldMk cId="3552285547" sldId="262"/>
            <ac:picMk id="28" creationId="{A7E6DFB9-4828-5DAD-A64B-C58F2EFE0527}"/>
          </ac:picMkLst>
        </pc:picChg>
      </pc:sldChg>
      <pc:sldChg chg="addSp modSp mod">
        <pc:chgData name="Amy Ward" userId="c9b4cf37-c40f-42c4-812a-4f73567e69c1" providerId="ADAL" clId="{2D666CCE-47D4-4261-826D-E4EE9BF86D1F}" dt="2025-06-12T14:00:37.884" v="22" actId="14100"/>
        <pc:sldMkLst>
          <pc:docMk/>
          <pc:sldMk cId="2209395372" sldId="263"/>
        </pc:sldMkLst>
        <pc:spChg chg="add mod">
          <ac:chgData name="Amy Ward" userId="c9b4cf37-c40f-42c4-812a-4f73567e69c1" providerId="ADAL" clId="{2D666CCE-47D4-4261-826D-E4EE9BF86D1F}" dt="2025-06-12T14:00:37.884" v="22" actId="14100"/>
          <ac:spMkLst>
            <pc:docMk/>
            <pc:sldMk cId="2209395372" sldId="263"/>
            <ac:spMk id="2" creationId="{91BC8EFB-6EE8-02C6-EE9F-E0C78045C5CC}"/>
          </ac:spMkLst>
        </pc:spChg>
        <pc:spChg chg="mod">
          <ac:chgData name="Amy Ward" userId="c9b4cf37-c40f-42c4-812a-4f73567e69c1" providerId="ADAL" clId="{2D666CCE-47D4-4261-826D-E4EE9BF86D1F}" dt="2025-06-12T14:00:23.699" v="18" actId="1076"/>
          <ac:spMkLst>
            <pc:docMk/>
            <pc:sldMk cId="2209395372" sldId="263"/>
            <ac:spMk id="5" creationId="{0EA337FF-157A-1A29-5A56-C75D79B11A91}"/>
          </ac:spMkLst>
        </pc:spChg>
        <pc:spChg chg="mod">
          <ac:chgData name="Amy Ward" userId="c9b4cf37-c40f-42c4-812a-4f73567e69c1" providerId="ADAL" clId="{2D666CCE-47D4-4261-826D-E4EE9BF86D1F}" dt="2025-06-12T14:00:23.699" v="18" actId="1076"/>
          <ac:spMkLst>
            <pc:docMk/>
            <pc:sldMk cId="2209395372" sldId="263"/>
            <ac:spMk id="8" creationId="{C0D7338C-EC06-D244-3085-56CE9CDEB499}"/>
          </ac:spMkLst>
        </pc:spChg>
        <pc:spChg chg="mod">
          <ac:chgData name="Amy Ward" userId="c9b4cf37-c40f-42c4-812a-4f73567e69c1" providerId="ADAL" clId="{2D666CCE-47D4-4261-826D-E4EE9BF86D1F}" dt="2025-06-12T14:00:23.699" v="18" actId="1076"/>
          <ac:spMkLst>
            <pc:docMk/>
            <pc:sldMk cId="2209395372" sldId="263"/>
            <ac:spMk id="11" creationId="{63BD9FC6-F18B-029E-6A6A-D81D90E00F9F}"/>
          </ac:spMkLst>
        </pc:spChg>
        <pc:spChg chg="mod">
          <ac:chgData name="Amy Ward" userId="c9b4cf37-c40f-42c4-812a-4f73567e69c1" providerId="ADAL" clId="{2D666CCE-47D4-4261-826D-E4EE9BF86D1F}" dt="2025-06-12T13:59:01.263" v="0"/>
          <ac:spMkLst>
            <pc:docMk/>
            <pc:sldMk cId="2209395372" sldId="263"/>
            <ac:spMk id="15" creationId="{69C7B32B-4F70-C1F0-118A-93F40A68125B}"/>
          </ac:spMkLst>
        </pc:spChg>
        <pc:spChg chg="mod">
          <ac:chgData name="Amy Ward" userId="c9b4cf37-c40f-42c4-812a-4f73567e69c1" providerId="ADAL" clId="{2D666CCE-47D4-4261-826D-E4EE9BF86D1F}" dt="2025-06-12T14:00:23.699" v="18" actId="1076"/>
          <ac:spMkLst>
            <pc:docMk/>
            <pc:sldMk cId="2209395372" sldId="263"/>
            <ac:spMk id="16" creationId="{31E2A235-791A-3E74-A949-38EEE2069593}"/>
          </ac:spMkLst>
        </pc:spChg>
        <pc:spChg chg="mod">
          <ac:chgData name="Amy Ward" userId="c9b4cf37-c40f-42c4-812a-4f73567e69c1" providerId="ADAL" clId="{2D666CCE-47D4-4261-826D-E4EE9BF86D1F}" dt="2025-06-12T14:00:23.699" v="18" actId="1076"/>
          <ac:spMkLst>
            <pc:docMk/>
            <pc:sldMk cId="2209395372" sldId="263"/>
            <ac:spMk id="21" creationId="{3EDDC30D-0593-12F3-7965-9468314BE8A3}"/>
          </ac:spMkLst>
        </pc:spChg>
        <pc:picChg chg="mod">
          <ac:chgData name="Amy Ward" userId="c9b4cf37-c40f-42c4-812a-4f73567e69c1" providerId="ADAL" clId="{2D666CCE-47D4-4261-826D-E4EE9BF86D1F}" dt="2025-06-12T14:00:23.699" v="18" actId="1076"/>
          <ac:picMkLst>
            <pc:docMk/>
            <pc:sldMk cId="2209395372" sldId="263"/>
            <ac:picMk id="19" creationId="{EA86BD16-0F24-A000-D4E1-DF4B16B55826}"/>
          </ac:picMkLst>
        </pc:picChg>
        <pc:picChg chg="mod">
          <ac:chgData name="Amy Ward" userId="c9b4cf37-c40f-42c4-812a-4f73567e69c1" providerId="ADAL" clId="{2D666CCE-47D4-4261-826D-E4EE9BF86D1F}" dt="2025-06-12T14:00:23.699" v="18" actId="1076"/>
          <ac:picMkLst>
            <pc:docMk/>
            <pc:sldMk cId="2209395372" sldId="263"/>
            <ac:picMk id="20" creationId="{D5098EF9-10A1-B296-A052-51D4B0F09D3F}"/>
          </ac:picMkLst>
        </pc:picChg>
        <pc:picChg chg="mod">
          <ac:chgData name="Amy Ward" userId="c9b4cf37-c40f-42c4-812a-4f73567e69c1" providerId="ADAL" clId="{2D666CCE-47D4-4261-826D-E4EE9BF86D1F}" dt="2025-06-12T14:00:23.699" v="18" actId="1076"/>
          <ac:picMkLst>
            <pc:docMk/>
            <pc:sldMk cId="2209395372" sldId="263"/>
            <ac:picMk id="22" creationId="{0CB3614E-C1BA-971D-AF66-35E7AB197E5D}"/>
          </ac:picMkLst>
        </pc:picChg>
        <pc:picChg chg="mod">
          <ac:chgData name="Amy Ward" userId="c9b4cf37-c40f-42c4-812a-4f73567e69c1" providerId="ADAL" clId="{2D666CCE-47D4-4261-826D-E4EE9BF86D1F}" dt="2025-06-12T14:00:23.699" v="18" actId="1076"/>
          <ac:picMkLst>
            <pc:docMk/>
            <pc:sldMk cId="2209395372" sldId="263"/>
            <ac:picMk id="23" creationId="{F7CAF5B3-1DE6-71A5-34DB-FB5796EF12D8}"/>
          </ac:picMkLst>
        </pc:picChg>
        <pc:picChg chg="mod">
          <ac:chgData name="Amy Ward" userId="c9b4cf37-c40f-42c4-812a-4f73567e69c1" providerId="ADAL" clId="{2D666CCE-47D4-4261-826D-E4EE9BF86D1F}" dt="2025-06-12T14:00:23.699" v="18" actId="1076"/>
          <ac:picMkLst>
            <pc:docMk/>
            <pc:sldMk cId="2209395372" sldId="263"/>
            <ac:picMk id="24" creationId="{2A0286D1-848C-2A14-A415-50C6F0A8BAE4}"/>
          </ac:picMkLst>
        </pc:picChg>
      </pc:sldChg>
      <pc:sldChg chg="addSp delSp modSp mod">
        <pc:chgData name="Amy Ward" userId="c9b4cf37-c40f-42c4-812a-4f73567e69c1" providerId="ADAL" clId="{2D666CCE-47D4-4261-826D-E4EE9BF86D1F}" dt="2025-06-12T14:01:07.918" v="32" actId="14100"/>
        <pc:sldMkLst>
          <pc:docMk/>
          <pc:sldMk cId="1151906083" sldId="265"/>
        </pc:sldMkLst>
        <pc:spChg chg="add mod">
          <ac:chgData name="Amy Ward" userId="c9b4cf37-c40f-42c4-812a-4f73567e69c1" providerId="ADAL" clId="{2D666CCE-47D4-4261-826D-E4EE9BF86D1F}" dt="2025-06-12T14:01:07.918" v="32" actId="14100"/>
          <ac:spMkLst>
            <pc:docMk/>
            <pc:sldMk cId="1151906083" sldId="265"/>
            <ac:spMk id="10" creationId="{22AB1B4A-BF8C-F6D5-C475-A8C192AFA963}"/>
          </ac:spMkLst>
        </pc:spChg>
        <pc:graphicFrameChg chg="add del modGraphic">
          <ac:chgData name="Amy Ward" userId="c9b4cf37-c40f-42c4-812a-4f73567e69c1" providerId="ADAL" clId="{2D666CCE-47D4-4261-826D-E4EE9BF86D1F}" dt="2025-06-12T14:00:52.946" v="28" actId="478"/>
          <ac:graphicFrameMkLst>
            <pc:docMk/>
            <pc:sldMk cId="1151906083" sldId="265"/>
            <ac:graphicFrameMk id="9" creationId="{5C6FC4AF-B7C0-D1FD-14DC-1A3568899599}"/>
          </ac:graphicFrameMkLst>
        </pc:graphicFrameChg>
        <pc:picChg chg="mod">
          <ac:chgData name="Amy Ward" userId="c9b4cf37-c40f-42c4-812a-4f73567e69c1" providerId="ADAL" clId="{2D666CCE-47D4-4261-826D-E4EE9BF86D1F}" dt="2025-06-12T14:00:48.821" v="26" actId="1076"/>
          <ac:picMkLst>
            <pc:docMk/>
            <pc:sldMk cId="1151906083" sldId="265"/>
            <ac:picMk id="2" creationId="{260C750D-4E73-4B77-DFDF-F4FE54C3D230}"/>
          </ac:picMkLst>
        </pc:picChg>
        <pc:picChg chg="mod">
          <ac:chgData name="Amy Ward" userId="c9b4cf37-c40f-42c4-812a-4f73567e69c1" providerId="ADAL" clId="{2D666CCE-47D4-4261-826D-E4EE9BF86D1F}" dt="2025-06-12T14:00:48.821" v="26" actId="1076"/>
          <ac:picMkLst>
            <pc:docMk/>
            <pc:sldMk cId="1151906083" sldId="265"/>
            <ac:picMk id="3" creationId="{D873081D-D793-B1FA-7B26-1BE4B6272A3B}"/>
          </ac:picMkLst>
        </pc:picChg>
        <pc:picChg chg="mod">
          <ac:chgData name="Amy Ward" userId="c9b4cf37-c40f-42c4-812a-4f73567e69c1" providerId="ADAL" clId="{2D666CCE-47D4-4261-826D-E4EE9BF86D1F}" dt="2025-06-12T14:00:48.821" v="26" actId="1076"/>
          <ac:picMkLst>
            <pc:docMk/>
            <pc:sldMk cId="1151906083" sldId="265"/>
            <ac:picMk id="4" creationId="{1A594C6D-93DD-6A9E-EDB8-3CB149B7A734}"/>
          </ac:picMkLst>
        </pc:picChg>
        <pc:picChg chg="mod">
          <ac:chgData name="Amy Ward" userId="c9b4cf37-c40f-42c4-812a-4f73567e69c1" providerId="ADAL" clId="{2D666CCE-47D4-4261-826D-E4EE9BF86D1F}" dt="2025-06-12T14:00:48.821" v="26" actId="1076"/>
          <ac:picMkLst>
            <pc:docMk/>
            <pc:sldMk cId="1151906083" sldId="265"/>
            <ac:picMk id="5" creationId="{0640BC2A-C106-7433-11AF-2E65E2575CA1}"/>
          </ac:picMkLst>
        </pc:picChg>
        <pc:picChg chg="mod">
          <ac:chgData name="Amy Ward" userId="c9b4cf37-c40f-42c4-812a-4f73567e69c1" providerId="ADAL" clId="{2D666CCE-47D4-4261-826D-E4EE9BF86D1F}" dt="2025-06-12T14:00:48.821" v="26" actId="1076"/>
          <ac:picMkLst>
            <pc:docMk/>
            <pc:sldMk cId="1151906083" sldId="265"/>
            <ac:picMk id="6" creationId="{94472F25-FF5E-C85D-0C3C-579B864F476A}"/>
          </ac:picMkLst>
        </pc:picChg>
        <pc:picChg chg="mod">
          <ac:chgData name="Amy Ward" userId="c9b4cf37-c40f-42c4-812a-4f73567e69c1" providerId="ADAL" clId="{2D666CCE-47D4-4261-826D-E4EE9BF86D1F}" dt="2025-06-12T14:00:48.821" v="26" actId="1076"/>
          <ac:picMkLst>
            <pc:docMk/>
            <pc:sldMk cId="1151906083" sldId="265"/>
            <ac:picMk id="7" creationId="{99547BD1-2A94-45A6-F82E-9DC46C01ADBC}"/>
          </ac:picMkLst>
        </pc:picChg>
      </pc:sldChg>
      <pc:sldChg chg="delSp modSp del mod">
        <pc:chgData name="Amy Ward" userId="c9b4cf37-c40f-42c4-812a-4f73567e69c1" providerId="ADAL" clId="{2D666CCE-47D4-4261-826D-E4EE9BF86D1F}" dt="2025-06-12T13:59:50.530" v="9" actId="47"/>
        <pc:sldMkLst>
          <pc:docMk/>
          <pc:sldMk cId="3647664218" sldId="293"/>
        </pc:sldMkLst>
        <pc:spChg chg="del mod">
          <ac:chgData name="Amy Ward" userId="c9b4cf37-c40f-42c4-812a-4f73567e69c1" providerId="ADAL" clId="{2D666CCE-47D4-4261-826D-E4EE9BF86D1F}" dt="2025-06-12T13:59:31.683" v="4" actId="21"/>
          <ac:spMkLst>
            <pc:docMk/>
            <pc:sldMk cId="3647664218" sldId="293"/>
            <ac:spMk id="6" creationId="{D989D657-7F77-95B5-DC8F-1145AE3D2E43}"/>
          </ac:spMkLst>
        </pc:spChg>
      </pc:sldChg>
      <pc:sldChg chg="delSp modSp del mod">
        <pc:chgData name="Amy Ward" userId="c9b4cf37-c40f-42c4-812a-4f73567e69c1" providerId="ADAL" clId="{2D666CCE-47D4-4261-826D-E4EE9BF86D1F}" dt="2025-06-12T14:00:18.429" v="17" actId="47"/>
        <pc:sldMkLst>
          <pc:docMk/>
          <pc:sldMk cId="2897145375" sldId="294"/>
        </pc:sldMkLst>
        <pc:spChg chg="del mod">
          <ac:chgData name="Amy Ward" userId="c9b4cf37-c40f-42c4-812a-4f73567e69c1" providerId="ADAL" clId="{2D666CCE-47D4-4261-826D-E4EE9BF86D1F}" dt="2025-06-12T14:00:03.629" v="12" actId="21"/>
          <ac:spMkLst>
            <pc:docMk/>
            <pc:sldMk cId="2897145375" sldId="294"/>
            <ac:spMk id="2" creationId="{6404FF49-90E2-5D7B-8D62-37979229465E}"/>
          </ac:spMkLst>
        </pc:spChg>
      </pc:sldChg>
      <pc:sldChg chg="delSp modSp del mod">
        <pc:chgData name="Amy Ward" userId="c9b4cf37-c40f-42c4-812a-4f73567e69c1" providerId="ADAL" clId="{2D666CCE-47D4-4261-826D-E4EE9BF86D1F}" dt="2025-06-12T14:00:39.923" v="23" actId="47"/>
        <pc:sldMkLst>
          <pc:docMk/>
          <pc:sldMk cId="1325827997" sldId="295"/>
        </pc:sldMkLst>
        <pc:spChg chg="del mod">
          <ac:chgData name="Amy Ward" userId="c9b4cf37-c40f-42c4-812a-4f73567e69c1" providerId="ADAL" clId="{2D666CCE-47D4-4261-826D-E4EE9BF86D1F}" dt="2025-06-12T14:00:29.270" v="19" actId="21"/>
          <ac:spMkLst>
            <pc:docMk/>
            <pc:sldMk cId="1325827997" sldId="295"/>
            <ac:spMk id="2" creationId="{91BC8EFB-6EE8-02C6-EE9F-E0C78045C5CC}"/>
          </ac:spMkLst>
        </pc:spChg>
      </pc:sldChg>
      <pc:sldChg chg="delSp modSp del mod">
        <pc:chgData name="Amy Ward" userId="c9b4cf37-c40f-42c4-812a-4f73567e69c1" providerId="ADAL" clId="{2D666CCE-47D4-4261-826D-E4EE9BF86D1F}" dt="2025-06-12T14:01:09.439" v="33" actId="47"/>
        <pc:sldMkLst>
          <pc:docMk/>
          <pc:sldMk cId="2063679453" sldId="296"/>
        </pc:sldMkLst>
        <pc:spChg chg="del mod">
          <ac:chgData name="Amy Ward" userId="c9b4cf37-c40f-42c4-812a-4f73567e69c1" providerId="ADAL" clId="{2D666CCE-47D4-4261-826D-E4EE9BF86D1F}" dt="2025-06-12T14:00:57.633" v="29" actId="21"/>
          <ac:spMkLst>
            <pc:docMk/>
            <pc:sldMk cId="2063679453" sldId="296"/>
            <ac:spMk id="8" creationId="{22AB1B4A-BF8C-F6D5-C475-A8C192AFA963}"/>
          </ac:spMkLst>
        </pc:spChg>
      </pc:sldChg>
      <pc:sldMasterChg chg="modSp modSldLayout">
        <pc:chgData name="Amy Ward" userId="c9b4cf37-c40f-42c4-812a-4f73567e69c1" providerId="ADAL" clId="{2D666CCE-47D4-4261-826D-E4EE9BF86D1F}" dt="2025-06-12T13:59:01.263" v="0"/>
        <pc:sldMasterMkLst>
          <pc:docMk/>
          <pc:sldMasterMk cId="1475200479" sldId="2147483648"/>
        </pc:sldMasterMkLst>
        <pc:spChg chg="mod">
          <ac:chgData name="Amy Ward" userId="c9b4cf37-c40f-42c4-812a-4f73567e69c1" providerId="ADAL" clId="{2D666CCE-47D4-4261-826D-E4EE9BF86D1F}" dt="2025-06-12T13:59:01.263" v="0"/>
          <ac:spMkLst>
            <pc:docMk/>
            <pc:sldMasterMk cId="1475200479" sldId="2147483648"/>
            <ac:spMk id="2" creationId="{FFEDE203-BFE1-CBA4-F235-DB91CD17962B}"/>
          </ac:spMkLst>
        </pc:spChg>
        <pc:spChg chg="mod">
          <ac:chgData name="Amy Ward" userId="c9b4cf37-c40f-42c4-812a-4f73567e69c1" providerId="ADAL" clId="{2D666CCE-47D4-4261-826D-E4EE9BF86D1F}" dt="2025-06-12T13:59:01.263" v="0"/>
          <ac:spMkLst>
            <pc:docMk/>
            <pc:sldMasterMk cId="1475200479" sldId="2147483648"/>
            <ac:spMk id="3" creationId="{5D6759DD-3FC3-6679-58F5-B1D06CA5BCB3}"/>
          </ac:spMkLst>
        </pc:spChg>
        <pc:spChg chg="mod">
          <ac:chgData name="Amy Ward" userId="c9b4cf37-c40f-42c4-812a-4f73567e69c1" providerId="ADAL" clId="{2D666CCE-47D4-4261-826D-E4EE9BF86D1F}" dt="2025-06-12T13:59:01.263" v="0"/>
          <ac:spMkLst>
            <pc:docMk/>
            <pc:sldMasterMk cId="1475200479" sldId="2147483648"/>
            <ac:spMk id="4" creationId="{C32D0763-14FA-7404-E971-168200180681}"/>
          </ac:spMkLst>
        </pc:spChg>
        <pc:spChg chg="mod">
          <ac:chgData name="Amy Ward" userId="c9b4cf37-c40f-42c4-812a-4f73567e69c1" providerId="ADAL" clId="{2D666CCE-47D4-4261-826D-E4EE9BF86D1F}" dt="2025-06-12T13:59:01.263" v="0"/>
          <ac:spMkLst>
            <pc:docMk/>
            <pc:sldMasterMk cId="1475200479" sldId="2147483648"/>
            <ac:spMk id="5" creationId="{1F55CBBA-2E29-5AF6-EE01-CDC7B60093DC}"/>
          </ac:spMkLst>
        </pc:spChg>
        <pc:spChg chg="mod">
          <ac:chgData name="Amy Ward" userId="c9b4cf37-c40f-42c4-812a-4f73567e69c1" providerId="ADAL" clId="{2D666CCE-47D4-4261-826D-E4EE9BF86D1F}" dt="2025-06-12T13:59:01.263" v="0"/>
          <ac:spMkLst>
            <pc:docMk/>
            <pc:sldMasterMk cId="1475200479" sldId="2147483648"/>
            <ac:spMk id="6" creationId="{7EE9FC8C-EE77-1016-BD96-398804DB70F9}"/>
          </ac:spMkLst>
        </pc:spChg>
        <pc:sldLayoutChg chg="modSp">
          <pc:chgData name="Amy Ward" userId="c9b4cf37-c40f-42c4-812a-4f73567e69c1" providerId="ADAL" clId="{2D666CCE-47D4-4261-826D-E4EE9BF86D1F}" dt="2025-06-12T13:59:01.263" v="0"/>
          <pc:sldLayoutMkLst>
            <pc:docMk/>
            <pc:sldMasterMk cId="1475200479" sldId="2147483648"/>
            <pc:sldLayoutMk cId="1558119657" sldId="2147483649"/>
          </pc:sldLayoutMkLst>
          <pc:spChg chg="mod">
            <ac:chgData name="Amy Ward" userId="c9b4cf37-c40f-42c4-812a-4f73567e69c1" providerId="ADAL" clId="{2D666CCE-47D4-4261-826D-E4EE9BF86D1F}" dt="2025-06-12T13:59:01.263" v="0"/>
            <ac:spMkLst>
              <pc:docMk/>
              <pc:sldMasterMk cId="1475200479" sldId="2147483648"/>
              <pc:sldLayoutMk cId="1558119657" sldId="2147483649"/>
              <ac:spMk id="2" creationId="{8989FD70-00A7-869C-37CE-F9887DEC3B4F}"/>
            </ac:spMkLst>
          </pc:spChg>
          <pc:spChg chg="mod">
            <ac:chgData name="Amy Ward" userId="c9b4cf37-c40f-42c4-812a-4f73567e69c1" providerId="ADAL" clId="{2D666CCE-47D4-4261-826D-E4EE9BF86D1F}" dt="2025-06-12T13:59:01.263" v="0"/>
            <ac:spMkLst>
              <pc:docMk/>
              <pc:sldMasterMk cId="1475200479" sldId="2147483648"/>
              <pc:sldLayoutMk cId="1558119657" sldId="2147483649"/>
              <ac:spMk id="3" creationId="{7960C90E-8464-3C82-D036-FCF1ABFB01A5}"/>
            </ac:spMkLst>
          </pc:spChg>
        </pc:sldLayoutChg>
        <pc:sldLayoutChg chg="modSp">
          <pc:chgData name="Amy Ward" userId="c9b4cf37-c40f-42c4-812a-4f73567e69c1" providerId="ADAL" clId="{2D666CCE-47D4-4261-826D-E4EE9BF86D1F}" dt="2025-06-12T13:59:01.263" v="0"/>
          <pc:sldLayoutMkLst>
            <pc:docMk/>
            <pc:sldMasterMk cId="1475200479" sldId="2147483648"/>
            <pc:sldLayoutMk cId="56752249" sldId="2147483651"/>
          </pc:sldLayoutMkLst>
          <pc:spChg chg="mod">
            <ac:chgData name="Amy Ward" userId="c9b4cf37-c40f-42c4-812a-4f73567e69c1" providerId="ADAL" clId="{2D666CCE-47D4-4261-826D-E4EE9BF86D1F}" dt="2025-06-12T13:59:01.263" v="0"/>
            <ac:spMkLst>
              <pc:docMk/>
              <pc:sldMasterMk cId="1475200479" sldId="2147483648"/>
              <pc:sldLayoutMk cId="56752249" sldId="2147483651"/>
              <ac:spMk id="2" creationId="{7C7B7E12-D9AA-9BE0-EC47-76E77399BBF5}"/>
            </ac:spMkLst>
          </pc:spChg>
          <pc:spChg chg="mod">
            <ac:chgData name="Amy Ward" userId="c9b4cf37-c40f-42c4-812a-4f73567e69c1" providerId="ADAL" clId="{2D666CCE-47D4-4261-826D-E4EE9BF86D1F}" dt="2025-06-12T13:59:01.263" v="0"/>
            <ac:spMkLst>
              <pc:docMk/>
              <pc:sldMasterMk cId="1475200479" sldId="2147483648"/>
              <pc:sldLayoutMk cId="56752249" sldId="2147483651"/>
              <ac:spMk id="3" creationId="{F76AA9B0-2DF5-EC1B-3428-2A9645C61BFB}"/>
            </ac:spMkLst>
          </pc:spChg>
        </pc:sldLayoutChg>
        <pc:sldLayoutChg chg="modSp">
          <pc:chgData name="Amy Ward" userId="c9b4cf37-c40f-42c4-812a-4f73567e69c1" providerId="ADAL" clId="{2D666CCE-47D4-4261-826D-E4EE9BF86D1F}" dt="2025-06-12T13:59:01.263" v="0"/>
          <pc:sldLayoutMkLst>
            <pc:docMk/>
            <pc:sldMasterMk cId="1475200479" sldId="2147483648"/>
            <pc:sldLayoutMk cId="3284918543" sldId="2147483652"/>
          </pc:sldLayoutMkLst>
          <pc:spChg chg="mod">
            <ac:chgData name="Amy Ward" userId="c9b4cf37-c40f-42c4-812a-4f73567e69c1" providerId="ADAL" clId="{2D666CCE-47D4-4261-826D-E4EE9BF86D1F}" dt="2025-06-12T13:59:01.263" v="0"/>
            <ac:spMkLst>
              <pc:docMk/>
              <pc:sldMasterMk cId="1475200479" sldId="2147483648"/>
              <pc:sldLayoutMk cId="3284918543" sldId="2147483652"/>
              <ac:spMk id="3" creationId="{EE8DFC9A-C6ED-979A-F38B-38213306D162}"/>
            </ac:spMkLst>
          </pc:spChg>
          <pc:spChg chg="mod">
            <ac:chgData name="Amy Ward" userId="c9b4cf37-c40f-42c4-812a-4f73567e69c1" providerId="ADAL" clId="{2D666CCE-47D4-4261-826D-E4EE9BF86D1F}" dt="2025-06-12T13:59:01.263" v="0"/>
            <ac:spMkLst>
              <pc:docMk/>
              <pc:sldMasterMk cId="1475200479" sldId="2147483648"/>
              <pc:sldLayoutMk cId="3284918543" sldId="2147483652"/>
              <ac:spMk id="4" creationId="{88922720-FBC3-E1A0-2654-C4A1DBE70E0A}"/>
            </ac:spMkLst>
          </pc:spChg>
        </pc:sldLayoutChg>
        <pc:sldLayoutChg chg="modSp">
          <pc:chgData name="Amy Ward" userId="c9b4cf37-c40f-42c4-812a-4f73567e69c1" providerId="ADAL" clId="{2D666CCE-47D4-4261-826D-E4EE9BF86D1F}" dt="2025-06-12T13:59:01.263" v="0"/>
          <pc:sldLayoutMkLst>
            <pc:docMk/>
            <pc:sldMasterMk cId="1475200479" sldId="2147483648"/>
            <pc:sldLayoutMk cId="1361331041" sldId="2147483653"/>
          </pc:sldLayoutMkLst>
          <pc:spChg chg="mod">
            <ac:chgData name="Amy Ward" userId="c9b4cf37-c40f-42c4-812a-4f73567e69c1" providerId="ADAL" clId="{2D666CCE-47D4-4261-826D-E4EE9BF86D1F}" dt="2025-06-12T13:59:01.263" v="0"/>
            <ac:spMkLst>
              <pc:docMk/>
              <pc:sldMasterMk cId="1475200479" sldId="2147483648"/>
              <pc:sldLayoutMk cId="1361331041" sldId="2147483653"/>
              <ac:spMk id="2" creationId="{D1382BD2-BE10-6EA3-6C56-5637D2BE049F}"/>
            </ac:spMkLst>
          </pc:spChg>
          <pc:spChg chg="mod">
            <ac:chgData name="Amy Ward" userId="c9b4cf37-c40f-42c4-812a-4f73567e69c1" providerId="ADAL" clId="{2D666CCE-47D4-4261-826D-E4EE9BF86D1F}" dt="2025-06-12T13:59:01.263" v="0"/>
            <ac:spMkLst>
              <pc:docMk/>
              <pc:sldMasterMk cId="1475200479" sldId="2147483648"/>
              <pc:sldLayoutMk cId="1361331041" sldId="2147483653"/>
              <ac:spMk id="3" creationId="{E7E3288C-AE35-578B-89D7-F268F817AE5D}"/>
            </ac:spMkLst>
          </pc:spChg>
          <pc:spChg chg="mod">
            <ac:chgData name="Amy Ward" userId="c9b4cf37-c40f-42c4-812a-4f73567e69c1" providerId="ADAL" clId="{2D666CCE-47D4-4261-826D-E4EE9BF86D1F}" dt="2025-06-12T13:59:01.263" v="0"/>
            <ac:spMkLst>
              <pc:docMk/>
              <pc:sldMasterMk cId="1475200479" sldId="2147483648"/>
              <pc:sldLayoutMk cId="1361331041" sldId="2147483653"/>
              <ac:spMk id="4" creationId="{1983E15B-760E-A1EA-E942-A93AD3988EF4}"/>
            </ac:spMkLst>
          </pc:spChg>
          <pc:spChg chg="mod">
            <ac:chgData name="Amy Ward" userId="c9b4cf37-c40f-42c4-812a-4f73567e69c1" providerId="ADAL" clId="{2D666CCE-47D4-4261-826D-E4EE9BF86D1F}" dt="2025-06-12T13:59:01.263" v="0"/>
            <ac:spMkLst>
              <pc:docMk/>
              <pc:sldMasterMk cId="1475200479" sldId="2147483648"/>
              <pc:sldLayoutMk cId="1361331041" sldId="2147483653"/>
              <ac:spMk id="5" creationId="{46A67035-B2D4-0747-3CDC-9CE8D17EA0A3}"/>
            </ac:spMkLst>
          </pc:spChg>
          <pc:spChg chg="mod">
            <ac:chgData name="Amy Ward" userId="c9b4cf37-c40f-42c4-812a-4f73567e69c1" providerId="ADAL" clId="{2D666CCE-47D4-4261-826D-E4EE9BF86D1F}" dt="2025-06-12T13:59:01.263" v="0"/>
            <ac:spMkLst>
              <pc:docMk/>
              <pc:sldMasterMk cId="1475200479" sldId="2147483648"/>
              <pc:sldLayoutMk cId="1361331041" sldId="2147483653"/>
              <ac:spMk id="6" creationId="{22BC3B8D-D586-E198-A390-A49B9A9F9AAC}"/>
            </ac:spMkLst>
          </pc:spChg>
        </pc:sldLayoutChg>
        <pc:sldLayoutChg chg="modSp">
          <pc:chgData name="Amy Ward" userId="c9b4cf37-c40f-42c4-812a-4f73567e69c1" providerId="ADAL" clId="{2D666CCE-47D4-4261-826D-E4EE9BF86D1F}" dt="2025-06-12T13:59:01.263" v="0"/>
          <pc:sldLayoutMkLst>
            <pc:docMk/>
            <pc:sldMasterMk cId="1475200479" sldId="2147483648"/>
            <pc:sldLayoutMk cId="3511000954" sldId="2147483656"/>
          </pc:sldLayoutMkLst>
          <pc:spChg chg="mod">
            <ac:chgData name="Amy Ward" userId="c9b4cf37-c40f-42c4-812a-4f73567e69c1" providerId="ADAL" clId="{2D666CCE-47D4-4261-826D-E4EE9BF86D1F}" dt="2025-06-12T13:59:01.263" v="0"/>
            <ac:spMkLst>
              <pc:docMk/>
              <pc:sldMasterMk cId="1475200479" sldId="2147483648"/>
              <pc:sldLayoutMk cId="3511000954" sldId="2147483656"/>
              <ac:spMk id="2" creationId="{8BA6CC9A-3056-72D7-5238-AB4BEEE712B6}"/>
            </ac:spMkLst>
          </pc:spChg>
          <pc:spChg chg="mod">
            <ac:chgData name="Amy Ward" userId="c9b4cf37-c40f-42c4-812a-4f73567e69c1" providerId="ADAL" clId="{2D666CCE-47D4-4261-826D-E4EE9BF86D1F}" dt="2025-06-12T13:59:01.263" v="0"/>
            <ac:spMkLst>
              <pc:docMk/>
              <pc:sldMasterMk cId="1475200479" sldId="2147483648"/>
              <pc:sldLayoutMk cId="3511000954" sldId="2147483656"/>
              <ac:spMk id="3" creationId="{048E0F0F-A127-E132-6BA9-5948F593C845}"/>
            </ac:spMkLst>
          </pc:spChg>
          <pc:spChg chg="mod">
            <ac:chgData name="Amy Ward" userId="c9b4cf37-c40f-42c4-812a-4f73567e69c1" providerId="ADAL" clId="{2D666CCE-47D4-4261-826D-E4EE9BF86D1F}" dt="2025-06-12T13:59:01.263" v="0"/>
            <ac:spMkLst>
              <pc:docMk/>
              <pc:sldMasterMk cId="1475200479" sldId="2147483648"/>
              <pc:sldLayoutMk cId="3511000954" sldId="2147483656"/>
              <ac:spMk id="4" creationId="{F77F0209-3101-C81B-D6B0-FCF081FF7966}"/>
            </ac:spMkLst>
          </pc:spChg>
        </pc:sldLayoutChg>
        <pc:sldLayoutChg chg="modSp">
          <pc:chgData name="Amy Ward" userId="c9b4cf37-c40f-42c4-812a-4f73567e69c1" providerId="ADAL" clId="{2D666CCE-47D4-4261-826D-E4EE9BF86D1F}" dt="2025-06-12T13:59:01.263" v="0"/>
          <pc:sldLayoutMkLst>
            <pc:docMk/>
            <pc:sldMasterMk cId="1475200479" sldId="2147483648"/>
            <pc:sldLayoutMk cId="694347295" sldId="2147483657"/>
          </pc:sldLayoutMkLst>
          <pc:spChg chg="mod">
            <ac:chgData name="Amy Ward" userId="c9b4cf37-c40f-42c4-812a-4f73567e69c1" providerId="ADAL" clId="{2D666CCE-47D4-4261-826D-E4EE9BF86D1F}" dt="2025-06-12T13:59:01.263" v="0"/>
            <ac:spMkLst>
              <pc:docMk/>
              <pc:sldMasterMk cId="1475200479" sldId="2147483648"/>
              <pc:sldLayoutMk cId="694347295" sldId="2147483657"/>
              <ac:spMk id="2" creationId="{3C534BE7-9299-E6A5-8727-FAF1B0832387}"/>
            </ac:spMkLst>
          </pc:spChg>
          <pc:spChg chg="mod">
            <ac:chgData name="Amy Ward" userId="c9b4cf37-c40f-42c4-812a-4f73567e69c1" providerId="ADAL" clId="{2D666CCE-47D4-4261-826D-E4EE9BF86D1F}" dt="2025-06-12T13:59:01.263" v="0"/>
            <ac:spMkLst>
              <pc:docMk/>
              <pc:sldMasterMk cId="1475200479" sldId="2147483648"/>
              <pc:sldLayoutMk cId="694347295" sldId="2147483657"/>
              <ac:spMk id="3" creationId="{9546F961-DD1B-C359-8A54-1C036313654A}"/>
            </ac:spMkLst>
          </pc:spChg>
          <pc:spChg chg="mod">
            <ac:chgData name="Amy Ward" userId="c9b4cf37-c40f-42c4-812a-4f73567e69c1" providerId="ADAL" clId="{2D666CCE-47D4-4261-826D-E4EE9BF86D1F}" dt="2025-06-12T13:59:01.263" v="0"/>
            <ac:spMkLst>
              <pc:docMk/>
              <pc:sldMasterMk cId="1475200479" sldId="2147483648"/>
              <pc:sldLayoutMk cId="694347295" sldId="2147483657"/>
              <ac:spMk id="4" creationId="{B90502A0-2BC4-AC80-1689-8662BCD8F35C}"/>
            </ac:spMkLst>
          </pc:spChg>
        </pc:sldLayoutChg>
        <pc:sldLayoutChg chg="modSp">
          <pc:chgData name="Amy Ward" userId="c9b4cf37-c40f-42c4-812a-4f73567e69c1" providerId="ADAL" clId="{2D666CCE-47D4-4261-826D-E4EE9BF86D1F}" dt="2025-06-12T13:59:01.263" v="0"/>
          <pc:sldLayoutMkLst>
            <pc:docMk/>
            <pc:sldMasterMk cId="1475200479" sldId="2147483648"/>
            <pc:sldLayoutMk cId="3861117710" sldId="2147483659"/>
          </pc:sldLayoutMkLst>
          <pc:spChg chg="mod">
            <ac:chgData name="Amy Ward" userId="c9b4cf37-c40f-42c4-812a-4f73567e69c1" providerId="ADAL" clId="{2D666CCE-47D4-4261-826D-E4EE9BF86D1F}" dt="2025-06-12T13:59:01.263" v="0"/>
            <ac:spMkLst>
              <pc:docMk/>
              <pc:sldMasterMk cId="1475200479" sldId="2147483648"/>
              <pc:sldLayoutMk cId="3861117710" sldId="2147483659"/>
              <ac:spMk id="2" creationId="{5CE2626B-540E-983C-C91A-B694EDF68F50}"/>
            </ac:spMkLst>
          </pc:spChg>
          <pc:spChg chg="mod">
            <ac:chgData name="Amy Ward" userId="c9b4cf37-c40f-42c4-812a-4f73567e69c1" providerId="ADAL" clId="{2D666CCE-47D4-4261-826D-E4EE9BF86D1F}" dt="2025-06-12T13:59:01.263" v="0"/>
            <ac:spMkLst>
              <pc:docMk/>
              <pc:sldMasterMk cId="1475200479" sldId="2147483648"/>
              <pc:sldLayoutMk cId="3861117710" sldId="2147483659"/>
              <ac:spMk id="3" creationId="{2DB22061-D6F2-5F2F-3A0B-0063A8A5A9EE}"/>
            </ac:spMkLst>
          </pc:spChg>
        </pc:sldLayoutChg>
      </pc:sldMaster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DC8EA-9FFD-4B36-A248-7577E005DF23}" type="datetimeFigureOut">
              <a:rPr lang="en-GB" smtClean="0"/>
              <a:t>12/06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23DFE-C401-438F-B4E2-BA9DD1A186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95468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DC8EA-9FFD-4B36-A248-7577E005DF23}" type="datetimeFigureOut">
              <a:rPr lang="en-GB" smtClean="0"/>
              <a:t>12/06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23DFE-C401-438F-B4E2-BA9DD1A186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66349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DC8EA-9FFD-4B36-A248-7577E005DF23}" type="datetimeFigureOut">
              <a:rPr lang="en-GB" smtClean="0"/>
              <a:t>12/06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23DFE-C401-438F-B4E2-BA9DD1A186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78857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DC8EA-9FFD-4B36-A248-7577E005DF23}" type="datetimeFigureOut">
              <a:rPr lang="en-GB" smtClean="0"/>
              <a:t>12/06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23DFE-C401-438F-B4E2-BA9DD1A186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79423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DC8EA-9FFD-4B36-A248-7577E005DF23}" type="datetimeFigureOut">
              <a:rPr lang="en-GB" smtClean="0"/>
              <a:t>12/06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23DFE-C401-438F-B4E2-BA9DD1A186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45201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DC8EA-9FFD-4B36-A248-7577E005DF23}" type="datetimeFigureOut">
              <a:rPr lang="en-GB" smtClean="0"/>
              <a:t>12/06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23DFE-C401-438F-B4E2-BA9DD1A186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26751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DC8EA-9FFD-4B36-A248-7577E005DF23}" type="datetimeFigureOut">
              <a:rPr lang="en-GB" smtClean="0"/>
              <a:t>12/06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23DFE-C401-438F-B4E2-BA9DD1A186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68124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DC8EA-9FFD-4B36-A248-7577E005DF23}" type="datetimeFigureOut">
              <a:rPr lang="en-GB" smtClean="0"/>
              <a:t>12/06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23DFE-C401-438F-B4E2-BA9DD1A186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26670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DC8EA-9FFD-4B36-A248-7577E005DF23}" type="datetimeFigureOut">
              <a:rPr lang="en-GB" smtClean="0"/>
              <a:t>12/06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23DFE-C401-438F-B4E2-BA9DD1A186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25702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DC8EA-9FFD-4B36-A248-7577E005DF23}" type="datetimeFigureOut">
              <a:rPr lang="en-GB" smtClean="0"/>
              <a:t>12/06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23DFE-C401-438F-B4E2-BA9DD1A186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04278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DC8EA-9FFD-4B36-A248-7577E005DF23}" type="datetimeFigureOut">
              <a:rPr lang="en-GB" smtClean="0"/>
              <a:t>12/06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23DFE-C401-438F-B4E2-BA9DD1A186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55323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8DDC8EA-9FFD-4B36-A248-7577E005DF23}" type="datetimeFigureOut">
              <a:rPr lang="en-GB" smtClean="0"/>
              <a:t>12/06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1D23DFE-C401-438F-B4E2-BA9DD1A186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07543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6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7" Type="http://schemas.openxmlformats.org/officeDocument/2006/relationships/image" Target="../media/image17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73398B-4F10-1231-AFF8-4B59C303BECC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GB" dirty="0"/>
              <a:t>Supplementary Data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76BBFFC-C30D-B307-533F-12DFA136A571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876755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F1C10AFA-1EBE-9515-9D42-A6EEC825A03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63285020"/>
              </p:ext>
            </p:extLst>
          </p:nvPr>
        </p:nvGraphicFramePr>
        <p:xfrm>
          <a:off x="-445603" y="0"/>
          <a:ext cx="7303603" cy="37428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5665295" imgH="2902842" progId="Prism9.Document">
                  <p:embed/>
                </p:oleObj>
              </mc:Choice>
              <mc:Fallback>
                <p:oleObj name="Prism 9" r:id="rId2" imgW="5665295" imgH="2902842" progId="Prism9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F1C10AFA-1EBE-9515-9D42-A6EEC825A03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-445603" y="0"/>
                        <a:ext cx="7303603" cy="37428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D989D657-7F77-95B5-DC8F-1145AE3D2E43}"/>
              </a:ext>
            </a:extLst>
          </p:cNvPr>
          <p:cNvSpPr txBox="1"/>
          <p:nvPr/>
        </p:nvSpPr>
        <p:spPr>
          <a:xfrm>
            <a:off x="0" y="3742867"/>
            <a:ext cx="68580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Fig. S1: Immunisation with pertussis alone (</a:t>
            </a:r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Ptx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) or with peptides </a:t>
            </a:r>
          </a:p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(OVA or RBP-3 1-20) emulsified in CFA leads to a significant increase in CD4 cell numbers in the eye, greater on day 5 compared with day 10. </a:t>
            </a:r>
          </a:p>
        </p:txBody>
      </p:sp>
    </p:spTree>
    <p:extLst>
      <p:ext uri="{BB962C8B-B14F-4D97-AF65-F5344CB8AC3E}">
        <p14:creationId xmlns:p14="http://schemas.microsoft.com/office/powerpoint/2010/main" val="39152021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Picture 20">
            <a:extLst>
              <a:ext uri="{FF2B5EF4-FFF2-40B4-BE49-F238E27FC236}">
                <a16:creationId xmlns:a16="http://schemas.microsoft.com/office/drawing/2014/main" id="{9FB78F33-52A4-7CAC-D5C0-8285DCCED50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2333" t="20591" r="32128" b="18971"/>
          <a:stretch/>
        </p:blipFill>
        <p:spPr>
          <a:xfrm>
            <a:off x="2582554" y="2710244"/>
            <a:ext cx="2063065" cy="1411792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92BB825E-8BD2-4738-56BA-25E09813BEB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2899" r="31110"/>
          <a:stretch/>
        </p:blipFill>
        <p:spPr>
          <a:xfrm>
            <a:off x="2642655" y="508900"/>
            <a:ext cx="2002965" cy="2249541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3F2D6A5F-FCEE-F8EB-B489-940FCED6749D}"/>
              </a:ext>
            </a:extLst>
          </p:cNvPr>
          <p:cNvSpPr txBox="1"/>
          <p:nvPr/>
        </p:nvSpPr>
        <p:spPr>
          <a:xfrm>
            <a:off x="2727328" y="2614553"/>
            <a:ext cx="760144" cy="2682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43" dirty="0"/>
              <a:t>Cluster 5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62A34D4-D32A-A682-940B-D603E817AB5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0333" r="36000"/>
          <a:stretch/>
        </p:blipFill>
        <p:spPr>
          <a:xfrm>
            <a:off x="387493" y="731033"/>
            <a:ext cx="2237886" cy="3843698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0C0C48F5-0D40-D943-C167-CE048AEB69B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4708" t="42355" r="32128" b="39837"/>
          <a:stretch/>
        </p:blipFill>
        <p:spPr>
          <a:xfrm>
            <a:off x="2621845" y="4148361"/>
            <a:ext cx="2131246" cy="448923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F0708FFE-D3C3-2FAF-14E9-D7A02ED8618C}"/>
              </a:ext>
            </a:extLst>
          </p:cNvPr>
          <p:cNvSpPr txBox="1"/>
          <p:nvPr/>
        </p:nvSpPr>
        <p:spPr>
          <a:xfrm>
            <a:off x="2686734" y="4035038"/>
            <a:ext cx="760144" cy="2682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43" dirty="0"/>
              <a:t>Cluster 9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11283C8-5CFF-C184-09F7-E2E19FB261F9}"/>
              </a:ext>
            </a:extLst>
          </p:cNvPr>
          <p:cNvSpPr txBox="1"/>
          <p:nvPr/>
        </p:nvSpPr>
        <p:spPr>
          <a:xfrm>
            <a:off x="549424" y="580142"/>
            <a:ext cx="760144" cy="2682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43" dirty="0"/>
              <a:t>Cluster 2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0DBB0F5-4D27-5A8E-786B-66650B29A11F}"/>
              </a:ext>
            </a:extLst>
          </p:cNvPr>
          <p:cNvSpPr txBox="1"/>
          <p:nvPr/>
        </p:nvSpPr>
        <p:spPr>
          <a:xfrm>
            <a:off x="2749515" y="580142"/>
            <a:ext cx="760144" cy="2682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43" dirty="0"/>
              <a:t>Cluster 4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973001C7-0682-EAEB-1E0E-40B0EC26AB9D}"/>
              </a:ext>
            </a:extLst>
          </p:cNvPr>
          <p:cNvGrpSpPr/>
          <p:nvPr/>
        </p:nvGrpSpPr>
        <p:grpSpPr>
          <a:xfrm>
            <a:off x="2742881" y="4539668"/>
            <a:ext cx="706361" cy="1119819"/>
            <a:chOff x="3703972" y="7679992"/>
            <a:chExt cx="1112353" cy="1763454"/>
          </a:xfrm>
        </p:grpSpPr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A7E6DFB9-4828-5DAD-A64B-C58F2EFE052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65931" t="37810" r="21490" b="38927"/>
            <a:stretch/>
          </p:blipFill>
          <p:spPr>
            <a:xfrm>
              <a:off x="3817311" y="7679992"/>
              <a:ext cx="999014" cy="1595332"/>
            </a:xfrm>
            <a:prstGeom prst="rect">
              <a:avLst/>
            </a:prstGeom>
            <a:solidFill>
              <a:srgbClr val="FFFF00"/>
            </a:solidFill>
          </p:spPr>
        </p:pic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409EFB58-4316-EA4C-2749-BAC200CC5273}"/>
                </a:ext>
              </a:extLst>
            </p:cNvPr>
            <p:cNvSpPr/>
            <p:nvPr/>
          </p:nvSpPr>
          <p:spPr>
            <a:xfrm>
              <a:off x="3703972" y="7679992"/>
              <a:ext cx="999014" cy="1763454"/>
            </a:xfrm>
            <a:prstGeom prst="rect">
              <a:avLst/>
            </a:prstGeom>
            <a:solidFill>
              <a:srgbClr val="FFFF00">
                <a:alpha val="5882"/>
              </a:srgb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143" dirty="0"/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6404FF49-90E2-5D7B-8D62-37979229465E}"/>
              </a:ext>
            </a:extLst>
          </p:cNvPr>
          <p:cNvSpPr txBox="1"/>
          <p:nvPr/>
        </p:nvSpPr>
        <p:spPr>
          <a:xfrm>
            <a:off x="263784" y="6639274"/>
            <a:ext cx="64238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Fig. S2. Genes upregulated in pathogenic cells grouped by k-means clustering</a:t>
            </a:r>
          </a:p>
        </p:txBody>
      </p:sp>
    </p:spTree>
    <p:extLst>
      <p:ext uri="{BB962C8B-B14F-4D97-AF65-F5344CB8AC3E}">
        <p14:creationId xmlns:p14="http://schemas.microsoft.com/office/powerpoint/2010/main" val="35522855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Picture 18">
            <a:extLst>
              <a:ext uri="{FF2B5EF4-FFF2-40B4-BE49-F238E27FC236}">
                <a16:creationId xmlns:a16="http://schemas.microsoft.com/office/drawing/2014/main" id="{EA86BD16-0F24-A000-D4E1-DF4B16B5582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4708" t="34598" r="32015" b="33985"/>
          <a:stretch/>
        </p:blipFill>
        <p:spPr>
          <a:xfrm>
            <a:off x="371936" y="788833"/>
            <a:ext cx="2252633" cy="980444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0CB3614E-C1BA-971D-AF66-35E7AB197E5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3689" t="9978" r="32016" b="9258"/>
          <a:stretch/>
        </p:blipFill>
        <p:spPr>
          <a:xfrm>
            <a:off x="2752986" y="826450"/>
            <a:ext cx="2292894" cy="2144811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D5098EF9-10A1-B296-A052-51D4B0F09D3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1001" r="35444"/>
          <a:stretch/>
        </p:blipFill>
        <p:spPr>
          <a:xfrm>
            <a:off x="375529" y="1929438"/>
            <a:ext cx="2353948" cy="4053355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F7CAF5B3-1DE6-71A5-34DB-FB5796EF12D8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5274" t="26706" r="32241" b="25267"/>
          <a:stretch/>
        </p:blipFill>
        <p:spPr>
          <a:xfrm>
            <a:off x="2858634" y="3308954"/>
            <a:ext cx="2114757" cy="1216896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2A0286D1-848C-2A14-A415-50C6F0A8BAE4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4935" t="33541" r="32128" b="32462"/>
          <a:stretch/>
        </p:blipFill>
        <p:spPr>
          <a:xfrm>
            <a:off x="2838323" y="4722148"/>
            <a:ext cx="2164363" cy="87406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0EA337FF-157A-1A29-5A56-C75D79B11A91}"/>
              </a:ext>
            </a:extLst>
          </p:cNvPr>
          <p:cNvSpPr txBox="1"/>
          <p:nvPr/>
        </p:nvSpPr>
        <p:spPr>
          <a:xfrm>
            <a:off x="427192" y="591921"/>
            <a:ext cx="760144" cy="2682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43" dirty="0"/>
              <a:t>Cluster 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0D7338C-EC06-D244-3085-56CE9CDEB499}"/>
              </a:ext>
            </a:extLst>
          </p:cNvPr>
          <p:cNvSpPr txBox="1"/>
          <p:nvPr/>
        </p:nvSpPr>
        <p:spPr>
          <a:xfrm>
            <a:off x="2902852" y="3137384"/>
            <a:ext cx="760144" cy="2682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43" dirty="0"/>
              <a:t>Cluster 7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3BD9FC6-F18B-029E-6A6A-D81D90E00F9F}"/>
              </a:ext>
            </a:extLst>
          </p:cNvPr>
          <p:cNvSpPr txBox="1"/>
          <p:nvPr/>
        </p:nvSpPr>
        <p:spPr>
          <a:xfrm>
            <a:off x="2902852" y="4655709"/>
            <a:ext cx="760144" cy="2682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43" dirty="0"/>
              <a:t>Cluster 8</a:t>
            </a: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F87AB0E5-202E-2568-B3A3-4218923881C6}"/>
              </a:ext>
            </a:extLst>
          </p:cNvPr>
          <p:cNvGrpSpPr/>
          <p:nvPr/>
        </p:nvGrpSpPr>
        <p:grpSpPr>
          <a:xfrm>
            <a:off x="2928257" y="5662656"/>
            <a:ext cx="706361" cy="1119819"/>
            <a:chOff x="9155468" y="4997736"/>
            <a:chExt cx="1112353" cy="1763454"/>
          </a:xfrm>
          <a:solidFill>
            <a:srgbClr val="FFFF00"/>
          </a:solidFill>
        </p:grpSpPr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8615ABDB-5D28-D1EC-6172-9CF9716D76C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65931" t="37810" r="21490" b="38927"/>
            <a:stretch/>
          </p:blipFill>
          <p:spPr>
            <a:xfrm>
              <a:off x="9268807" y="4997736"/>
              <a:ext cx="999014" cy="1595332"/>
            </a:xfrm>
            <a:prstGeom prst="rect">
              <a:avLst/>
            </a:prstGeom>
            <a:grpFill/>
          </p:spPr>
        </p:pic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69C7B32B-4F70-C1F0-118A-93F40A68125B}"/>
                </a:ext>
              </a:extLst>
            </p:cNvPr>
            <p:cNvSpPr/>
            <p:nvPr/>
          </p:nvSpPr>
          <p:spPr>
            <a:xfrm>
              <a:off x="9155468" y="4997736"/>
              <a:ext cx="999014" cy="1763454"/>
            </a:xfrm>
            <a:prstGeom prst="rect">
              <a:avLst/>
            </a:prstGeom>
            <a:solidFill>
              <a:srgbClr val="FFFF00">
                <a:alpha val="5882"/>
              </a:srgb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143" dirty="0"/>
            </a:p>
          </p:txBody>
        </p: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31E2A235-791A-3E74-A949-38EEE2069593}"/>
              </a:ext>
            </a:extLst>
          </p:cNvPr>
          <p:cNvSpPr txBox="1"/>
          <p:nvPr/>
        </p:nvSpPr>
        <p:spPr>
          <a:xfrm>
            <a:off x="2858633" y="671018"/>
            <a:ext cx="760144" cy="2682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43" dirty="0"/>
              <a:t>Cluster 6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EDDC30D-0593-12F3-7965-9468314BE8A3}"/>
              </a:ext>
            </a:extLst>
          </p:cNvPr>
          <p:cNvSpPr txBox="1"/>
          <p:nvPr/>
        </p:nvSpPr>
        <p:spPr>
          <a:xfrm>
            <a:off x="427192" y="1715839"/>
            <a:ext cx="760144" cy="2682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43" dirty="0"/>
              <a:t>Cluster 3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1BC8EFB-6EE8-02C6-EE9F-E0C78045C5CC}"/>
              </a:ext>
            </a:extLst>
          </p:cNvPr>
          <p:cNvSpPr txBox="1"/>
          <p:nvPr/>
        </p:nvSpPr>
        <p:spPr>
          <a:xfrm>
            <a:off x="0" y="7511632"/>
            <a:ext cx="6598024" cy="2682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43" dirty="0">
                <a:latin typeface="Arial" panose="020B0604020202020204" pitchFamily="34" charset="0"/>
                <a:cs typeface="Arial" panose="020B0604020202020204" pitchFamily="34" charset="0"/>
              </a:rPr>
              <a:t>Sup Fig. 3. Genes downregulated in pathogenic cells grouped by k-means clustering</a:t>
            </a:r>
          </a:p>
        </p:txBody>
      </p:sp>
    </p:spTree>
    <p:extLst>
      <p:ext uri="{BB962C8B-B14F-4D97-AF65-F5344CB8AC3E}">
        <p14:creationId xmlns:p14="http://schemas.microsoft.com/office/powerpoint/2010/main" val="220939537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60C750D-4E73-4B77-DFDF-F4FE54C3D23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33277" y="700369"/>
            <a:ext cx="1908000" cy="1240405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D873081D-D793-B1FA-7B26-1BE4B6272A3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59211" y="812533"/>
            <a:ext cx="1683221" cy="1094276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1A594C6D-93DD-6A9E-EDB8-3CB149B7A73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60707" y="1940774"/>
            <a:ext cx="2053143" cy="1334764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640BC2A-C106-7433-11AF-2E65E2575CA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01242" y="2040321"/>
            <a:ext cx="1908000" cy="1240405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94472F25-FF5E-C85D-0C3C-579B864F476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233278" y="3356022"/>
            <a:ext cx="2004578" cy="130319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99547BD1-2A94-45A6-F82E-9DC46C01ADB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237854" y="3414235"/>
            <a:ext cx="2004578" cy="1303193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22AB1B4A-BF8C-F6D5-C475-A8C192AFA963}"/>
              </a:ext>
            </a:extLst>
          </p:cNvPr>
          <p:cNvSpPr txBox="1"/>
          <p:nvPr/>
        </p:nvSpPr>
        <p:spPr>
          <a:xfrm>
            <a:off x="0" y="5078646"/>
            <a:ext cx="6526306" cy="4440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43" dirty="0">
                <a:latin typeface="Arial" panose="020B0604020202020204" pitchFamily="34" charset="0"/>
                <a:cs typeface="Arial" panose="020B0604020202020204" pitchFamily="34" charset="0"/>
              </a:rPr>
              <a:t>Sup Fig. 4. Analysis of leading edge genes from GSEA analysis of the CD4 pathogenic phenotype in active EAU and NKG2D knockouts</a:t>
            </a:r>
          </a:p>
        </p:txBody>
      </p:sp>
    </p:spTree>
    <p:extLst>
      <p:ext uri="{BB962C8B-B14F-4D97-AF65-F5344CB8AC3E}">
        <p14:creationId xmlns:p14="http://schemas.microsoft.com/office/powerpoint/2010/main" val="11519060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116</Words>
  <Application>Microsoft Office PowerPoint</Application>
  <PresentationFormat>Widescreen</PresentationFormat>
  <Paragraphs>15</Paragraphs>
  <Slides>5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ptos</vt:lpstr>
      <vt:lpstr>Aptos Display</vt:lpstr>
      <vt:lpstr>Arial</vt:lpstr>
      <vt:lpstr>Office Theme</vt:lpstr>
      <vt:lpstr>Prism 9</vt:lpstr>
      <vt:lpstr>Supplementary Data</vt:lpstr>
      <vt:lpstr>PowerPoint Presentation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my Ward</dc:creator>
  <cp:lastModifiedBy>Amy Ward</cp:lastModifiedBy>
  <cp:revision>1</cp:revision>
  <dcterms:created xsi:type="dcterms:W3CDTF">2025-06-12T13:56:53Z</dcterms:created>
  <dcterms:modified xsi:type="dcterms:W3CDTF">2025-06-12T14:01:11Z</dcterms:modified>
</cp:coreProperties>
</file>